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1" r:id="rId2"/>
    <p:sldId id="256" r:id="rId3"/>
    <p:sldId id="257" r:id="rId4"/>
    <p:sldId id="258" r:id="rId5"/>
    <p:sldId id="259" r:id="rId6"/>
    <p:sldId id="260" r:id="rId7"/>
    <p:sldId id="263" r:id="rId8"/>
    <p:sldId id="262" r:id="rId9"/>
    <p:sldId id="264" r:id="rId10"/>
    <p:sldId id="265" r:id="rId11"/>
    <p:sldId id="266" r:id="rId12"/>
    <p:sldId id="267" r:id="rId13"/>
    <p:sldId id="270" r:id="rId14"/>
    <p:sldId id="269" r:id="rId1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144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F37C57-FBC6-4B9E-A327-B62EF50A1A96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D5F057-8FE1-4DBF-AEDA-0704A26AFF4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010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D5F057-8FE1-4DBF-AEDA-0704A26AFF4C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198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67C47-628C-4683-BD45-A83842455FDC}" type="datetimeFigureOut">
              <a:rPr lang="zh-CN" altLang="en-US" smtClean="0"/>
              <a:pPr/>
              <a:t>2022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E28266-2EC3-4395-9330-48A4A6D35E8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sz="3200" b="1" dirty="0" smtClean="0"/>
              <a:t>1. Microscopy pictures for enzyme digestion</a:t>
            </a:r>
            <a:endParaRPr lang="zh-CN" altLang="en-US" sz="3200" b="1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0034" y="4857760"/>
            <a:ext cx="81439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S7 Optimized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ysi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solution composed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snail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and β-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mercaptoethanol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could totally disrupt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blastospore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C.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A),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tropicali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B) and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parapsilosi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C). However, has no effect on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blastospore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glabrat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(D) and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krusei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E).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34" y="214290"/>
            <a:ext cx="8231178" cy="4436398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>
            <a:spLocks/>
          </p:cNvSpPr>
          <p:nvPr/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spcBef>
                <a:spcPct val="0"/>
              </a:spcBef>
            </a:pPr>
            <a:r>
              <a:rPr lang="en-US" altLang="zh-CN" sz="3200" b="1" noProof="0" dirty="0" smtClean="0">
                <a:latin typeface="+mj-lt"/>
                <a:ea typeface="+mj-ea"/>
                <a:cs typeface="+mj-cs"/>
              </a:rPr>
              <a:t>4</a:t>
            </a:r>
            <a:r>
              <a:rPr lang="en-US" altLang="zh-CN" sz="3200" b="1" dirty="0" smtClean="0">
                <a:latin typeface="+mj-lt"/>
                <a:ea typeface="+mj-ea"/>
                <a:cs typeface="+mj-cs"/>
              </a:rPr>
              <a:t>. Sensitivity and specificity of duplex PCR</a:t>
            </a:r>
            <a:endParaRPr kumimoji="0" lang="zh-CN" altLang="en-US" sz="3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57158" y="5857892"/>
            <a:ext cx="84296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ig S8 Sensitivity of multiple PCR (specific primers and probes). (A)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(B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tropicali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parapsilosi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(D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glabrat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and (E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krusei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he numbers of 0-5 represent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nsity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of 10</a:t>
            </a:r>
            <a:r>
              <a:rPr lang="en-US" sz="1600" baseline="30000" dirty="0" smtClean="0">
                <a:latin typeface="Times New Roman" pitchFamily="18" charset="0"/>
                <a:cs typeface="Times New Roman" pitchFamily="18" charset="0"/>
              </a:rPr>
              <a:t>0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-10</a:t>
            </a:r>
            <a:r>
              <a:rPr lang="en-US" sz="1600" baseline="30000" dirty="0" smtClean="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CFU/ml, and NC represents a negative control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E:\论文\已发表论文原始稿件\AMB EX2022\数据\论文用图用表\第一部分\特异性引物的灵敏度\光滑灵敏度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472462" y="2029584"/>
            <a:ext cx="3600000" cy="1970920"/>
          </a:xfrm>
          <a:prstGeom prst="rect">
            <a:avLst/>
          </a:prstGeom>
          <a:noFill/>
        </p:spPr>
      </p:pic>
      <p:pic>
        <p:nvPicPr>
          <p:cNvPr id="2" name="Picture 3" descr="E:\论文\已发表论文原始稿件\AMB EX2022\数据\论文用图用表\第一部分\特异性引物的灵敏度\近平滑灵敏度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43372" y="2000240"/>
            <a:ext cx="3600000" cy="2018991"/>
          </a:xfrm>
          <a:prstGeom prst="rect">
            <a:avLst/>
          </a:prstGeom>
          <a:noFill/>
        </p:spPr>
      </p:pic>
      <p:pic>
        <p:nvPicPr>
          <p:cNvPr id="1028" name="Picture 4" descr="E:\论文\已发表论文原始稿件\AMB EX2022\数据\论文用图用表\第一部分\特异性引物的灵敏度\克柔灵敏度111.jp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43372" y="3942387"/>
            <a:ext cx="3600000" cy="1986943"/>
          </a:xfrm>
          <a:prstGeom prst="rect">
            <a:avLst/>
          </a:prstGeom>
          <a:noFill/>
        </p:spPr>
      </p:pic>
      <p:pic>
        <p:nvPicPr>
          <p:cNvPr id="1029" name="Picture 5" descr="E:\论文\已发表论文原始稿件\AMB EX2022\数据\论文用图用表\第一部分\特异性引物的灵敏度\热带灵敏度111.jp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472462" y="71414"/>
            <a:ext cx="3600000" cy="1954897"/>
          </a:xfrm>
          <a:prstGeom prst="rect">
            <a:avLst/>
          </a:prstGeom>
          <a:noFill/>
        </p:spPr>
      </p:pic>
      <p:pic>
        <p:nvPicPr>
          <p:cNvPr id="1030" name="Picture 6" descr="E:\论文\已发表论文原始稿件\AMB EX2022\数据\论文用图用表\第一部分\特异性引物的灵敏度\新白念灵敏度111.jp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43372" y="71414"/>
            <a:ext cx="3600000" cy="1954897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论文\已发表论文原始稿件\AMB EX2022\数据\论文用图用表\第一部分\通用灵敏度\通用（白念灵敏度）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348" y="142852"/>
            <a:ext cx="3600000" cy="1933531"/>
          </a:xfrm>
          <a:prstGeom prst="rect">
            <a:avLst/>
          </a:prstGeom>
          <a:noFill/>
        </p:spPr>
      </p:pic>
      <p:pic>
        <p:nvPicPr>
          <p:cNvPr id="2051" name="Picture 3" descr="E:\论文\已发表论文原始稿件\AMB EX2022\数据\论文用图用表\第一部分\通用灵敏度\通用（光滑灵敏度）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500562" y="2071678"/>
            <a:ext cx="3600000" cy="1965579"/>
          </a:xfrm>
          <a:prstGeom prst="rect">
            <a:avLst/>
          </a:prstGeom>
          <a:noFill/>
        </p:spPr>
      </p:pic>
      <p:pic>
        <p:nvPicPr>
          <p:cNvPr id="2052" name="Picture 4" descr="E:\论文\已发表论文原始稿件\AMB EX2022\数据\论文用图用表\第一部分\通用灵敏度\通用（近平滑灵敏度）.jp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14348" y="2071678"/>
            <a:ext cx="3600000" cy="1976261"/>
          </a:xfrm>
          <a:prstGeom prst="rect">
            <a:avLst/>
          </a:prstGeom>
          <a:noFill/>
        </p:spPr>
      </p:pic>
      <p:pic>
        <p:nvPicPr>
          <p:cNvPr id="2053" name="Picture 5" descr="E:\论文\已发表论文原始稿件\AMB EX2022\数据\论文用图用表\第一部分\通用灵敏度\通用（克柔灵敏度）.jp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14348" y="4000504"/>
            <a:ext cx="3600000" cy="1942522"/>
          </a:xfrm>
          <a:prstGeom prst="rect">
            <a:avLst/>
          </a:prstGeom>
          <a:noFill/>
        </p:spPr>
      </p:pic>
      <p:pic>
        <p:nvPicPr>
          <p:cNvPr id="2054" name="Picture 6" descr="E:\论文\已发表论文原始稿件\AMB EX2022\数据\论文用图用表\第一部分\通用灵敏度\通用（热带灵敏度）.jp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500562" y="142852"/>
            <a:ext cx="3600000" cy="1965579"/>
          </a:xfrm>
          <a:prstGeom prst="rect">
            <a:avLst/>
          </a:prstGeom>
          <a:noFill/>
        </p:spPr>
      </p:pic>
      <p:sp>
        <p:nvSpPr>
          <p:cNvPr id="9" name="TextBox 8"/>
          <p:cNvSpPr txBox="1"/>
          <p:nvPr/>
        </p:nvSpPr>
        <p:spPr>
          <a:xfrm>
            <a:off x="285720" y="5853742"/>
            <a:ext cx="842968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smtClean="0">
                <a:latin typeface="Times New Roman" pitchFamily="18" charset="0"/>
                <a:cs typeface="Times New Roman" pitchFamily="18" charset="0"/>
              </a:rPr>
              <a:t>Fig </a:t>
            </a:r>
            <a:r>
              <a:rPr lang="en-US" altLang="zh-CN" sz="1600" smtClean="0">
                <a:latin typeface="Times New Roman" pitchFamily="18" charset="0"/>
                <a:cs typeface="Times New Roman" pitchFamily="18" charset="0"/>
              </a:rPr>
              <a:t>S9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ensitivity of multiple PCR (universal primers and probes). (A)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(B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tropicali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parapsilosi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(D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glabrat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and (E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krusei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he numbers of 0-5 represent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nsity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of 10</a:t>
            </a:r>
            <a:r>
              <a:rPr lang="en-US" sz="1600" baseline="30000" dirty="0" smtClean="0">
                <a:latin typeface="Times New Roman" pitchFamily="18" charset="0"/>
                <a:cs typeface="Times New Roman" pitchFamily="18" charset="0"/>
              </a:rPr>
              <a:t>0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-10</a:t>
            </a:r>
            <a:r>
              <a:rPr lang="en-US" sz="1600" baseline="30000" dirty="0" smtClean="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CFU/ml, and NC represents a negative control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85720" y="4071942"/>
            <a:ext cx="864399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ig.S10 Specificity of duplex PCR. The amplification curve of A-E were: (A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andida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B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tropicali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parapsilosi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D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glabrat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E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krusei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(F), The curves by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universal primer to amplify five common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species: 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(1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tropicali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2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parapsilosi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3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) 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krusei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4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, (5)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Candida. </a:t>
            </a:r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glabrat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71529" y="585792"/>
            <a:ext cx="8143875" cy="3486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论文\多重PCR检测五种念珠菌\数据\论文用图用表\第一部分\显微镜下裂解图\Lyticas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14414" y="714356"/>
            <a:ext cx="6561164" cy="4203949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357290" y="5072074"/>
            <a:ext cx="73581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1 Digestive effect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on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(400×). (A)negative control, (B)130µg, (C)650µg, (D)1040µg,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E)2080µg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论文\多重PCR检测五种念珠菌\数据\论文用图用表\第一部分\显微镜下裂解图\snailas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428728" y="1000108"/>
            <a:ext cx="6506555" cy="4016392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500167" y="5143512"/>
            <a:ext cx="73581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2 Digestive effect of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snaila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on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400×). 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(A)negative control, (B)100U, (C)200U, (D)500U, (E)800U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论文\多重PCR检测五种念珠菌\数据\论文用图用表\第一部分\显微镜下裂解图\zomyl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00166" y="1000108"/>
            <a:ext cx="6399240" cy="3964568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500167" y="5143512"/>
            <a:ext cx="73581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3 Digestive effect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zymoly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on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400×). 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(A)negative 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control</a:t>
            </a:r>
            <a:r>
              <a:rPr lang="pl-PL" dirty="0">
                <a:latin typeface="Times New Roman" pitchFamily="18" charset="0"/>
                <a:cs typeface="Times New Roman" pitchFamily="18" charset="0"/>
              </a:rPr>
              <a:t>, (B) 5U, (C) 20U, (D) 50U, (E) </a:t>
            </a:r>
            <a:r>
              <a:rPr lang="pl-PL" dirty="0" smtClean="0">
                <a:latin typeface="Times New Roman" pitchFamily="18" charset="0"/>
                <a:cs typeface="Times New Roman" pitchFamily="18" charset="0"/>
              </a:rPr>
              <a:t>100U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论文\多重PCR检测五种念珠菌\数据\论文用图用表\第一部分\显微镜下裂解图\Gluanas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28728" y="642918"/>
            <a:ext cx="6789467" cy="4286280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500167" y="5143512"/>
            <a:ext cx="73581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4 Digestive effect of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glucan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on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Candida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albican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400×). 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A)negative control, (B) 40U, (C) 80U, (D) 160U, (E) 320U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 descr="E:\论文\多重PCR检测五种念珠菌\数据\论文用图用表\第一部分\显微镜下裂解图\蜗牛酶＋lyticas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00100" y="677555"/>
            <a:ext cx="6929784" cy="4275445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000100" y="5072074"/>
            <a:ext cx="77153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. S5 Combination use of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snailas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&amp;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400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×). (A)negative control, (B) 13µg snailase+2U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C) 65µg snailase+10U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(D) 130µg snailase+20U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(E) 650µg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nailase+100U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(F) 1040µg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nailase+200U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>
            <a:spLocks/>
          </p:cNvSpPr>
          <p:nvPr/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3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2. Interference</a:t>
            </a:r>
            <a:r>
              <a:rPr kumimoji="0" lang="en-US" altLang="zh-CN" sz="3200" b="1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experiment</a:t>
            </a:r>
            <a:endParaRPr kumimoji="0" lang="zh-CN" altLang="en-US" sz="3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857224" y="4500570"/>
            <a:ext cx="721523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.S6 PCR interference experiment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that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adding different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ysi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solution component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in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to the 50 µl PCR reaction system. (1) positive control, (2) 16 µg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snail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2.5U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Lyticas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(3) 0.05 µl </a:t>
            </a:r>
            <a:r>
              <a:rPr lang="el-GR" dirty="0" smtClean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mercaptoethanol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(4) 12.5mM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sorbitol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(5) 0.625mM EDTA, (6) negative control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348" y="285728"/>
            <a:ext cx="7410450" cy="4143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>
            <a:spLocks/>
          </p:cNvSpPr>
          <p:nvPr/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3200" b="1" dirty="0" smtClean="0">
                <a:latin typeface="+mj-lt"/>
                <a:ea typeface="+mj-ea"/>
                <a:cs typeface="+mj-cs"/>
              </a:rPr>
              <a:t>3</a:t>
            </a:r>
            <a:r>
              <a:rPr kumimoji="0" lang="en-US" altLang="zh-CN" sz="3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. Effect of optimized</a:t>
            </a:r>
            <a:r>
              <a:rPr kumimoji="0" lang="en-US" altLang="zh-CN" sz="3200" b="1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en-US" altLang="zh-CN" sz="3200" b="1" i="0" u="none" strike="noStrike" kern="1200" cap="none" spc="0" normalizeH="0" noProof="0" dirty="0" err="1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lysis</a:t>
            </a:r>
            <a:r>
              <a:rPr kumimoji="0" lang="en-US" altLang="zh-CN" sz="3200" b="1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solution on different </a:t>
            </a:r>
            <a:r>
              <a:rPr kumimoji="0" lang="en-US" altLang="zh-CN" sz="3200" b="1" i="1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Candida</a:t>
            </a:r>
            <a:r>
              <a:rPr kumimoji="0" lang="en-US" altLang="zh-CN" sz="3200" b="1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j-lt"/>
                <a:ea typeface="+mj-ea"/>
                <a:cs typeface="+mj-cs"/>
              </a:rPr>
              <a:t> species</a:t>
            </a:r>
            <a:endParaRPr kumimoji="0" lang="zh-CN" altLang="en-US" sz="32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7</TotalTime>
  <Words>541</Words>
  <Application>Microsoft Office PowerPoint</Application>
  <PresentationFormat>On-screen Show (4:3)</PresentationFormat>
  <Paragraphs>17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宋体</vt:lpstr>
      <vt:lpstr>Arial</vt:lpstr>
      <vt:lpstr>Calibri</vt:lpstr>
      <vt:lpstr>Times New Roman</vt:lpstr>
      <vt:lpstr>Office 主题</vt:lpstr>
      <vt:lpstr>1. Microscopy pictures for enzyme diges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Poornima Thiruvudaiselvi</cp:lastModifiedBy>
  <cp:revision>54</cp:revision>
  <dcterms:created xsi:type="dcterms:W3CDTF">2021-11-04T02:31:49Z</dcterms:created>
  <dcterms:modified xsi:type="dcterms:W3CDTF">2022-12-14T07:52:54Z</dcterms:modified>
</cp:coreProperties>
</file>